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99" autoAdjust="0"/>
    <p:restoredTop sz="94660"/>
  </p:normalViewPr>
  <p:slideViewPr>
    <p:cSldViewPr snapToGrid="0">
      <p:cViewPr>
        <p:scale>
          <a:sx n="90" d="100"/>
          <a:sy n="90" d="100"/>
        </p:scale>
        <p:origin x="792" y="42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50FD1-E667-46AE-9C05-0526E35E4953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56863-FF15-4161-B7C4-E0D135AEDD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1952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50FD1-E667-46AE-9C05-0526E35E4953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56863-FF15-4161-B7C4-E0D135AEDD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7378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50FD1-E667-46AE-9C05-0526E35E4953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56863-FF15-4161-B7C4-E0D135AEDD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5539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50FD1-E667-46AE-9C05-0526E35E4953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56863-FF15-4161-B7C4-E0D135AEDD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6788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50FD1-E667-46AE-9C05-0526E35E4953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56863-FF15-4161-B7C4-E0D135AEDD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88871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50FD1-E667-46AE-9C05-0526E35E4953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56863-FF15-4161-B7C4-E0D135AEDD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9877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50FD1-E667-46AE-9C05-0526E35E4953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56863-FF15-4161-B7C4-E0D135AEDD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219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50FD1-E667-46AE-9C05-0526E35E4953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56863-FF15-4161-B7C4-E0D135AEDD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75218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50FD1-E667-46AE-9C05-0526E35E4953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56863-FF15-4161-B7C4-E0D135AEDD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1423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50FD1-E667-46AE-9C05-0526E35E4953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56863-FF15-4161-B7C4-E0D135AEDD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23161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50FD1-E667-46AE-9C05-0526E35E4953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56863-FF15-4161-B7C4-E0D135AEDD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6648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50FD1-E667-46AE-9C05-0526E35E4953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B56863-FF15-4161-B7C4-E0D135AEDD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4788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/>
          <p:cNvSpPr/>
          <p:nvPr/>
        </p:nvSpPr>
        <p:spPr>
          <a:xfrm>
            <a:off x="364759" y="-1734"/>
            <a:ext cx="201208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ed39_MN, </a:t>
            </a:r>
            <a:r>
              <a:rPr lang="en-GB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ningothelial 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217693" y="2400205"/>
            <a:ext cx="16273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ed29_MN,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abdoid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290228" y="-1734"/>
            <a:ext cx="1773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ed40_MN,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broblastic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64759" y="2400205"/>
            <a:ext cx="20217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ed43_MN,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ammomatous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217693" y="-1734"/>
            <a:ext cx="17783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ed38_MN, </a:t>
            </a:r>
            <a:r>
              <a:rPr lang="en-GB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ansitional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8690535" y="-1734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10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5764539" y="-1734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10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2837601" y="240020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10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8690535" y="240020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40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2837601" y="-1734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20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764539" y="240020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40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290228" y="2400205"/>
            <a:ext cx="1611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ed79_MN,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rdoid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405624" y="6617181"/>
            <a:ext cx="209749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Patternless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 growth (sheeting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3232665" y="6617181"/>
            <a:ext cx="738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Necrosis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7328283" y="6617181"/>
            <a:ext cx="114646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Brain invasion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4651807" y="6617181"/>
            <a:ext cx="219964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Small cells with high N/C ratio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049814" y="4889673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20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184904" y="4889673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10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6338390" y="4889673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20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8491919" y="4889673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20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tangle 50"/>
          <p:cNvSpPr/>
          <p:nvPr/>
        </p:nvSpPr>
        <p:spPr>
          <a:xfrm>
            <a:off x="6885537" y="4889673"/>
            <a:ext cx="90281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ed13_MN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Rectangle 51"/>
          <p:cNvSpPr/>
          <p:nvPr/>
        </p:nvSpPr>
        <p:spPr>
          <a:xfrm>
            <a:off x="443432" y="4889673"/>
            <a:ext cx="90281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ed72_MN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2596960" y="4889673"/>
            <a:ext cx="90281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ed58_MN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4732050" y="4889673"/>
            <a:ext cx="90281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ed58_MN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3525" y="235500"/>
            <a:ext cx="2887980" cy="2156460"/>
          </a:xfrm>
          <a:prstGeom prst="rect">
            <a:avLst/>
          </a:prstGeom>
        </p:spPr>
      </p:pic>
      <p:pic>
        <p:nvPicPr>
          <p:cNvPr id="3" name="Picture 2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90228" y="235500"/>
            <a:ext cx="2887200" cy="2156400"/>
          </a:xfrm>
          <a:prstGeom prst="rect">
            <a:avLst/>
          </a:prstGeom>
        </p:spPr>
      </p:pic>
      <p:pic>
        <p:nvPicPr>
          <p:cNvPr id="4" name="Picture 3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6216150" y="235500"/>
            <a:ext cx="2887200" cy="2156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3525" y="2651100"/>
            <a:ext cx="2887980" cy="215646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90228" y="2651100"/>
            <a:ext cx="2887980" cy="215646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19750" y="2647500"/>
            <a:ext cx="2887980" cy="215646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0912" y="5134010"/>
            <a:ext cx="2026920" cy="1516380"/>
          </a:xfrm>
          <a:prstGeom prst="rect">
            <a:avLst/>
          </a:prstGeom>
        </p:spPr>
      </p:pic>
      <p:pic>
        <p:nvPicPr>
          <p:cNvPr id="10" name="Picture 9"/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2588340" y="5134010"/>
            <a:ext cx="2026800" cy="151638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738168" y="5134010"/>
            <a:ext cx="2026920" cy="1516380"/>
          </a:xfrm>
          <a:prstGeom prst="rect">
            <a:avLst/>
          </a:prstGeom>
        </p:spPr>
      </p:pic>
      <p:pic>
        <p:nvPicPr>
          <p:cNvPr id="20" name="Picture 19"/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6888117" y="5134010"/>
            <a:ext cx="2026800" cy="151638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7197" y="5083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197" y="484497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8036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6</TotalTime>
  <Words>48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ديمه محمد  حسين</dc:creator>
  <cp:lastModifiedBy>ديمه محمد  حسين</cp:lastModifiedBy>
  <cp:revision>27</cp:revision>
  <dcterms:created xsi:type="dcterms:W3CDTF">2015-02-25T12:31:40Z</dcterms:created>
  <dcterms:modified xsi:type="dcterms:W3CDTF">2018-05-02T10:56:47Z</dcterms:modified>
</cp:coreProperties>
</file>